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4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08"/>
    <p:restoredTop sz="92978" autoAdjust="0"/>
  </p:normalViewPr>
  <p:slideViewPr>
    <p:cSldViewPr snapToGrid="0" snapToObjects="1">
      <p:cViewPr>
        <p:scale>
          <a:sx n="140" d="100"/>
          <a:sy n="140" d="100"/>
        </p:scale>
        <p:origin x="1032" y="14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9A1CFD81-C916-604D-AF90-33187627BA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3402856"/>
              </p:ext>
            </p:extLst>
          </p:nvPr>
        </p:nvGraphicFramePr>
        <p:xfrm>
          <a:off x="909082" y="820958"/>
          <a:ext cx="7783035" cy="11159684"/>
        </p:xfrm>
        <a:graphic>
          <a:graphicData uri="http://schemas.openxmlformats.org/drawingml/2006/table">
            <a:tbl>
              <a:tblPr/>
              <a:tblGrid>
                <a:gridCol w="1556607">
                  <a:extLst>
                    <a:ext uri="{9D8B030D-6E8A-4147-A177-3AD203B41FA5}">
                      <a16:colId xmlns:a16="http://schemas.microsoft.com/office/drawing/2014/main" val="3307313413"/>
                    </a:ext>
                  </a:extLst>
                </a:gridCol>
                <a:gridCol w="1556607">
                  <a:extLst>
                    <a:ext uri="{9D8B030D-6E8A-4147-A177-3AD203B41FA5}">
                      <a16:colId xmlns:a16="http://schemas.microsoft.com/office/drawing/2014/main" val="4003626004"/>
                    </a:ext>
                  </a:extLst>
                </a:gridCol>
                <a:gridCol w="1556607">
                  <a:extLst>
                    <a:ext uri="{9D8B030D-6E8A-4147-A177-3AD203B41FA5}">
                      <a16:colId xmlns:a16="http://schemas.microsoft.com/office/drawing/2014/main" val="2726372312"/>
                    </a:ext>
                  </a:extLst>
                </a:gridCol>
                <a:gridCol w="1556607">
                  <a:extLst>
                    <a:ext uri="{9D8B030D-6E8A-4147-A177-3AD203B41FA5}">
                      <a16:colId xmlns:a16="http://schemas.microsoft.com/office/drawing/2014/main" val="1408698044"/>
                    </a:ext>
                  </a:extLst>
                </a:gridCol>
                <a:gridCol w="1556607">
                  <a:extLst>
                    <a:ext uri="{9D8B030D-6E8A-4147-A177-3AD203B41FA5}">
                      <a16:colId xmlns:a16="http://schemas.microsoft.com/office/drawing/2014/main" val="2611619285"/>
                    </a:ext>
                  </a:extLst>
                </a:gridCol>
              </a:tblGrid>
              <a:tr h="223552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lementary table 3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enes encoding secreted protein in breast cancer cell lines reported by Ziegler YS, et al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013818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QSOX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4H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G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IF4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C23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0887810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PO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LK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D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S20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GFBI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703127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GR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TSD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ME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2M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F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3220560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DCB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NXA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GFBP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PC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TS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3578415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YR6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C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PI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K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TP6A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2469402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APDHS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SA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TPRG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YWHAG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GFBP7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857392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R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F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FL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YWHAE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AMA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589693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LRG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PRS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IF4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S1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CM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8358263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ALU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SP90A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GFBP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NRPD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PSF6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461766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LOD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HBS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N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IST1H4I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I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0043875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IST1H2BK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1A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YL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L8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QPCT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543986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WISP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SP90AB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ZG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PI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3H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6565429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KK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NHB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TP5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YWHAZ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A1L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805246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LST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P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TX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IF5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REM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863819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SS2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4A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S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UBE2L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7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2609535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KBP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FH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U2AF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EF1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UBA3E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22093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N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1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YWHAQ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uba4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IGYF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722983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7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16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APK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UCB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D10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1798898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FEMP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XCL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4A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LT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NKAR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8202165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DH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GALS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KT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PTB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77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4864720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OD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MGB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RP2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IAL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T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7212142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EB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76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FR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675025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GK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LDO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DIA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KBP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CSK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4769615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1R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A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XL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LOD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XNDC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885455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F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AA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DI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UCB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AM3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520444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RPINA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TPRF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H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MNB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FG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806719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X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F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EF1A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GH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849804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IM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SPD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100A1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PLP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RCAM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1342352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ST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SPA8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1CAM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MOD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MARCC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50607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GF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PT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DX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DX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HSR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4684290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BZ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DH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FF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UB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551779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1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6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SPA1L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R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12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9409473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3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I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HBS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HX9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MA3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45284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1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M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HBS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GALS3B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LSTN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82414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6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CAM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B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FGE8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2AFJ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3876175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PO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EF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CTN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FEM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INAGL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830703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GG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5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US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STL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GF2B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754378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MB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LS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UP6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NT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TSZ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504183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LKB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KCSH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AGLN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IM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KK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267829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LPI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KM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BMX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MAN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UBQLN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1698098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LDO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KR1B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H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ARDB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PS28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1554944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PO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IMP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PH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DX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WD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7910389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FF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D4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ATR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MA3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LEC11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6847943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UBB4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CA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ATA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UBB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UVBL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143495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APDH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BR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RKL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AMB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LN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9595834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P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PE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ASN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AMC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OXL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5638918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RPINE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SPA6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M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L4A6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YOU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5581620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RPIND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M2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DI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D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T14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8348479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18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GFBP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A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AG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YNC1LI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4229604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RT8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IGFBP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M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YNC1H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6019719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NO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CL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TS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LN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4651062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PI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B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SPA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TB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6793783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PM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GAM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AGLU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OLC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151077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PM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DH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CP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UMA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7482174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RPINE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YL12A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NRNPH2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DIA6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728444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DHB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CL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OXL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LE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6606836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EFM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I3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PI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ONO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34" charset="-128"/>
                        <a:ea typeface="Yu Gothic" panose="020B0400000000000000" pitchFamily="34" charset="-128"/>
                      </a:endParaRP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4426871"/>
                  </a:ext>
                </a:extLst>
              </a:tr>
              <a:tr h="1361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OS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GC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YL6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CBP1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34" charset="-128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5674" marR="5674" marT="5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47553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0393752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302</Words>
  <Application>Microsoft Macintosh PowerPoint</Application>
  <PresentationFormat>A3 297x420 mm</PresentationFormat>
  <Paragraphs>28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8</cp:revision>
  <cp:lastPrinted>2019-11-15T20:26:41Z</cp:lastPrinted>
  <dcterms:created xsi:type="dcterms:W3CDTF">2019-06-11T17:31:31Z</dcterms:created>
  <dcterms:modified xsi:type="dcterms:W3CDTF">2021-07-09T02:37:23Z</dcterms:modified>
  <cp:category/>
</cp:coreProperties>
</file>